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40538" cy="71993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991967-1D48-445A-AB31-A6792B845C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0920" y="288720"/>
            <a:ext cx="615780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0920" y="1679040"/>
            <a:ext cx="6157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0920" y="4161600"/>
            <a:ext cx="6157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5E4346-1A58-4F53-B1B8-2A4E81A777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0920" y="288720"/>
            <a:ext cx="615780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0920" y="1679040"/>
            <a:ext cx="300492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496320" y="1679040"/>
            <a:ext cx="300492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0920" y="4161600"/>
            <a:ext cx="300492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496320" y="4161600"/>
            <a:ext cx="300492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10B0C1-897A-43D0-A63E-F3B614F3C98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0920" y="288720"/>
            <a:ext cx="615780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0920" y="1679040"/>
            <a:ext cx="198252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2800" y="1679040"/>
            <a:ext cx="198252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05040" y="1679040"/>
            <a:ext cx="198252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0920" y="4161600"/>
            <a:ext cx="198252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2800" y="4161600"/>
            <a:ext cx="198252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05040" y="4161600"/>
            <a:ext cx="198252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61342A-FA65-4292-86A9-C392AC2480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0920" y="288720"/>
            <a:ext cx="615780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0920" y="1679040"/>
            <a:ext cx="6157800" cy="475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2D12A7-37F1-4422-9BD2-2799ABE4C7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0920" y="288720"/>
            <a:ext cx="615780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0920" y="1679040"/>
            <a:ext cx="6157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785BEB-C716-4312-ADD7-474595FD18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0920" y="288720"/>
            <a:ext cx="615780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0920" y="1679040"/>
            <a:ext cx="300492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496320" y="1679040"/>
            <a:ext cx="300492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14FDCE-F8F0-49B6-8D2A-64497C0FF9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0920" y="288720"/>
            <a:ext cx="615780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2C50DF-0F23-4352-8723-F5D5841872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0920" y="288720"/>
            <a:ext cx="6157800" cy="5556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071BBC-99F2-4FD4-A137-DBF4B41010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0920" y="288720"/>
            <a:ext cx="615780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0920" y="1679040"/>
            <a:ext cx="300492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496320" y="1679040"/>
            <a:ext cx="300492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0920" y="4161600"/>
            <a:ext cx="300492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DB47B3-98A5-4EDC-A45E-752284C523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0920" y="288720"/>
            <a:ext cx="615780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0920" y="1679040"/>
            <a:ext cx="300492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496320" y="1679040"/>
            <a:ext cx="300492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496320" y="4161600"/>
            <a:ext cx="300492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9C524B-9805-46CB-A086-D80EB5E2DB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0920" y="288720"/>
            <a:ext cx="615780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0920" y="1679040"/>
            <a:ext cx="300492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496320" y="1679040"/>
            <a:ext cx="300492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0920" y="4161600"/>
            <a:ext cx="6157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0047D6-6C08-4533-9B8B-F42A5A18B8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0920" y="288720"/>
            <a:ext cx="6157800" cy="119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0920" y="1679040"/>
            <a:ext cx="6157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1280" y="6557760"/>
            <a:ext cx="1596960" cy="50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36400" y="6557760"/>
            <a:ext cx="2166840" cy="50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02120" y="6557760"/>
            <a:ext cx="1596960" cy="50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575033-8487-4DB5-9F32-2A9082DF2F7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08000" y="111240"/>
            <a:ext cx="34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816280" y="0"/>
            <a:ext cx="129852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1280" indent="-341280" algn="ctr">
              <a:spcBef>
                <a:spcPts val="349"/>
              </a:spcBef>
              <a:tabLst>
                <a:tab algn="l" pos="0"/>
                <a:tab algn="l" pos="341280"/>
                <a:tab algn="l" pos="1255680"/>
                <a:tab algn="l" pos="2170080"/>
                <a:tab algn="l" pos="3084480"/>
                <a:tab algn="l" pos="3998880"/>
                <a:tab algn="l" pos="4913280"/>
                <a:tab algn="l" pos="5827680"/>
                <a:tab algn="l" pos="6742080"/>
                <a:tab algn="l" pos="7656480"/>
                <a:tab algn="l" pos="8570880"/>
                <a:tab algn="l" pos="9485280"/>
                <a:tab algn="l" pos="1039968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A4_54N0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rot="16200000">
            <a:off x="1019160" y="1797120"/>
            <a:ext cx="960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BP_91N2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1836720" y="299880"/>
            <a:ext cx="2871720" cy="316728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2104920" y="318960"/>
            <a:ext cx="2305080" cy="69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024280" y="2271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435760" y="22716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964240" y="22716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488040" y="22716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021560" y="22716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8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800360" y="376200"/>
            <a:ext cx="304560" cy="3076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847880" y="361800"/>
            <a:ext cx="247680" cy="2867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881360" y="3222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688040" y="50796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688040" y="69840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688040" y="89388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688040" y="109368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688040" y="129384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688040" y="149400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688040" y="169380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688040" y="188424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8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688040" y="207972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9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640520" y="2274840"/>
            <a:ext cx="51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640520" y="2455920"/>
            <a:ext cx="51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1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640520" y="2655720"/>
            <a:ext cx="51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2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640520" y="2855880"/>
            <a:ext cx="51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3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640520" y="3056040"/>
            <a:ext cx="51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4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645560" y="3246480"/>
            <a:ext cx="51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50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430440" y="5054760"/>
            <a:ext cx="398520" cy="687240"/>
          </a:xfrm>
          <a:custGeom>
            <a:avLst/>
            <a:gdLst/>
            <a:ahLst/>
            <a:rect l="l" t="t" r="r" b="b"/>
            <a:pathLst>
              <a:path w="255" h="459">
                <a:moveTo>
                  <a:pt x="0" y="30"/>
                </a:moveTo>
                <a:lnTo>
                  <a:pt x="249" y="459"/>
                </a:lnTo>
                <a:lnTo>
                  <a:pt x="255" y="435"/>
                </a:lnTo>
                <a:lnTo>
                  <a:pt x="6" y="0"/>
                </a:lnTo>
                <a:lnTo>
                  <a:pt x="0" y="30"/>
                </a:lnTo>
                <a:close/>
              </a:path>
            </a:pathLst>
          </a:custGeom>
          <a:solidFill>
            <a:srgbClr val="dddddd"/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H="1">
            <a:off x="3396960" y="4989600"/>
            <a:ext cx="333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786200" y="5040360"/>
            <a:ext cx="438120" cy="700200"/>
          </a:xfrm>
          <a:custGeom>
            <a:avLst/>
            <a:gdLst/>
            <a:ahLst/>
            <a:rect l="l" t="t" r="r" b="b"/>
            <a:pathLst>
              <a:path w="276" h="441">
                <a:moveTo>
                  <a:pt x="0" y="18"/>
                </a:moveTo>
                <a:lnTo>
                  <a:pt x="267" y="441"/>
                </a:lnTo>
                <a:lnTo>
                  <a:pt x="276" y="423"/>
                </a:lnTo>
                <a:lnTo>
                  <a:pt x="15" y="0"/>
                </a:lnTo>
                <a:lnTo>
                  <a:pt x="0" y="18"/>
                </a:lnTo>
                <a:close/>
              </a:path>
            </a:pathLst>
          </a:custGeom>
          <a:solidFill>
            <a:srgbClr val="dddddd"/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700520" y="5030640"/>
            <a:ext cx="414360" cy="709920"/>
          </a:xfrm>
          <a:custGeom>
            <a:avLst/>
            <a:gdLst/>
            <a:ahLst/>
            <a:rect l="l" t="t" r="r" b="b"/>
            <a:pathLst>
              <a:path w="261" h="447">
                <a:moveTo>
                  <a:pt x="0" y="21"/>
                </a:moveTo>
                <a:lnTo>
                  <a:pt x="237" y="447"/>
                </a:lnTo>
                <a:lnTo>
                  <a:pt x="261" y="429"/>
                </a:lnTo>
                <a:lnTo>
                  <a:pt x="21" y="0"/>
                </a:lnTo>
                <a:lnTo>
                  <a:pt x="0" y="21"/>
                </a:lnTo>
                <a:close/>
              </a:path>
            </a:pathLst>
          </a:custGeom>
          <a:solidFill>
            <a:srgbClr val="dddddd"/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557600" y="5021280"/>
            <a:ext cx="405000" cy="719280"/>
          </a:xfrm>
          <a:custGeom>
            <a:avLst/>
            <a:gdLst/>
            <a:ahLst/>
            <a:rect l="l" t="t" r="r" b="b"/>
            <a:pathLst>
              <a:path w="255" h="453">
                <a:moveTo>
                  <a:pt x="0" y="24"/>
                </a:moveTo>
                <a:lnTo>
                  <a:pt x="240" y="453"/>
                </a:lnTo>
                <a:lnTo>
                  <a:pt x="255" y="432"/>
                </a:lnTo>
                <a:lnTo>
                  <a:pt x="21" y="0"/>
                </a:lnTo>
                <a:lnTo>
                  <a:pt x="0" y="24"/>
                </a:lnTo>
                <a:close/>
              </a:path>
            </a:pathLst>
          </a:custGeom>
          <a:solidFill>
            <a:srgbClr val="dddddd"/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4486320" y="5021280"/>
            <a:ext cx="419040" cy="733320"/>
          </a:xfrm>
          <a:custGeom>
            <a:avLst/>
            <a:gdLst/>
            <a:ahLst/>
            <a:rect l="l" t="t" r="r" b="b"/>
            <a:pathLst>
              <a:path w="264" h="462">
                <a:moveTo>
                  <a:pt x="0" y="24"/>
                </a:moveTo>
                <a:lnTo>
                  <a:pt x="243" y="462"/>
                </a:lnTo>
                <a:lnTo>
                  <a:pt x="264" y="444"/>
                </a:lnTo>
                <a:lnTo>
                  <a:pt x="18" y="0"/>
                </a:lnTo>
                <a:lnTo>
                  <a:pt x="0" y="24"/>
                </a:lnTo>
                <a:close/>
              </a:path>
            </a:pathLst>
          </a:custGeom>
          <a:solidFill>
            <a:srgbClr val="dddddd"/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362480" y="4987800"/>
            <a:ext cx="428760" cy="771480"/>
          </a:xfrm>
          <a:custGeom>
            <a:avLst/>
            <a:gdLst/>
            <a:ahLst/>
            <a:rect l="l" t="t" r="r" b="b"/>
            <a:pathLst>
              <a:path w="270" h="486">
                <a:moveTo>
                  <a:pt x="0" y="39"/>
                </a:moveTo>
                <a:lnTo>
                  <a:pt x="246" y="486"/>
                </a:lnTo>
                <a:lnTo>
                  <a:pt x="270" y="459"/>
                </a:lnTo>
                <a:lnTo>
                  <a:pt x="18" y="0"/>
                </a:lnTo>
                <a:lnTo>
                  <a:pt x="0" y="39"/>
                </a:lnTo>
                <a:close/>
              </a:path>
            </a:pathLst>
          </a:custGeom>
          <a:solidFill>
            <a:srgbClr val="dddddd"/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262400" y="5016600"/>
            <a:ext cx="405000" cy="728640"/>
          </a:xfrm>
          <a:custGeom>
            <a:avLst/>
            <a:gdLst/>
            <a:ahLst/>
            <a:rect l="l" t="t" r="r" b="b"/>
            <a:pathLst>
              <a:path w="255" h="459">
                <a:moveTo>
                  <a:pt x="0" y="30"/>
                </a:moveTo>
                <a:lnTo>
                  <a:pt x="249" y="459"/>
                </a:lnTo>
                <a:lnTo>
                  <a:pt x="255" y="435"/>
                </a:lnTo>
                <a:lnTo>
                  <a:pt x="6" y="0"/>
                </a:lnTo>
                <a:lnTo>
                  <a:pt x="0" y="30"/>
                </a:lnTo>
                <a:close/>
              </a:path>
            </a:pathLst>
          </a:custGeom>
          <a:solidFill>
            <a:srgbClr val="dddddd"/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4114800" y="4983120"/>
            <a:ext cx="442800" cy="743040"/>
          </a:xfrm>
          <a:custGeom>
            <a:avLst/>
            <a:gdLst/>
            <a:ahLst/>
            <a:rect l="l" t="t" r="r" b="b"/>
            <a:pathLst>
              <a:path w="279" h="468">
                <a:moveTo>
                  <a:pt x="0" y="48"/>
                </a:moveTo>
                <a:lnTo>
                  <a:pt x="231" y="468"/>
                </a:lnTo>
                <a:lnTo>
                  <a:pt x="279" y="453"/>
                </a:lnTo>
                <a:lnTo>
                  <a:pt x="24" y="0"/>
                </a:lnTo>
                <a:lnTo>
                  <a:pt x="0" y="48"/>
                </a:lnTo>
                <a:close/>
              </a:path>
            </a:pathLst>
          </a:custGeom>
          <a:solidFill>
            <a:srgbClr val="dddddd"/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805200" y="5002200"/>
            <a:ext cx="623880" cy="743040"/>
          </a:xfrm>
          <a:custGeom>
            <a:avLst/>
            <a:gdLst/>
            <a:ahLst/>
            <a:rect l="l" t="t" r="r" b="b"/>
            <a:pathLst>
              <a:path w="393" h="468">
                <a:moveTo>
                  <a:pt x="0" y="39"/>
                </a:moveTo>
                <a:lnTo>
                  <a:pt x="255" y="468"/>
                </a:lnTo>
                <a:lnTo>
                  <a:pt x="393" y="453"/>
                </a:lnTo>
                <a:lnTo>
                  <a:pt x="129" y="0"/>
                </a:lnTo>
                <a:lnTo>
                  <a:pt x="0" y="39"/>
                </a:lnTo>
                <a:close/>
              </a:path>
            </a:pathLst>
          </a:custGeom>
          <a:solidFill>
            <a:srgbClr val="dddddd"/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562200" y="5021280"/>
            <a:ext cx="457200" cy="714240"/>
          </a:xfrm>
          <a:custGeom>
            <a:avLst/>
            <a:gdLst/>
            <a:ahLst/>
            <a:rect l="l" t="t" r="r" b="b"/>
            <a:pathLst>
              <a:path w="288" h="450">
                <a:moveTo>
                  <a:pt x="0" y="21"/>
                </a:moveTo>
                <a:lnTo>
                  <a:pt x="255" y="450"/>
                </a:lnTo>
                <a:lnTo>
                  <a:pt x="288" y="432"/>
                </a:lnTo>
                <a:lnTo>
                  <a:pt x="3" y="0"/>
                </a:lnTo>
                <a:lnTo>
                  <a:pt x="0" y="21"/>
                </a:lnTo>
                <a:close/>
              </a:path>
            </a:pathLst>
          </a:custGeom>
          <a:solidFill>
            <a:srgbClr val="dddddd"/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494160" y="5048280"/>
            <a:ext cx="430200" cy="716040"/>
          </a:xfrm>
          <a:custGeom>
            <a:avLst/>
            <a:gdLst/>
            <a:ahLst/>
            <a:rect l="l" t="t" r="r" b="b"/>
            <a:pathLst>
              <a:path w="261" h="459">
                <a:moveTo>
                  <a:pt x="0" y="24"/>
                </a:moveTo>
                <a:lnTo>
                  <a:pt x="240" y="459"/>
                </a:lnTo>
                <a:lnTo>
                  <a:pt x="261" y="423"/>
                </a:lnTo>
                <a:lnTo>
                  <a:pt x="9" y="0"/>
                </a:lnTo>
                <a:lnTo>
                  <a:pt x="0" y="24"/>
                </a:lnTo>
                <a:close/>
              </a:path>
            </a:pathLst>
          </a:custGeom>
          <a:solidFill>
            <a:srgbClr val="dddddd"/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rot="16200000">
            <a:off x="4001760" y="4138560"/>
            <a:ext cx="1434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A4_54N07.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rot="16200000">
            <a:off x="3890880" y="4138560"/>
            <a:ext cx="1434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A4_54N07.3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rot="16200000">
            <a:off x="3789000" y="4138560"/>
            <a:ext cx="1434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A4_54N07.3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rot="16200000">
            <a:off x="3678120" y="4138560"/>
            <a:ext cx="1434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A4_54N07.3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rot="16200000">
            <a:off x="3547800" y="4138560"/>
            <a:ext cx="1434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A4_54N07.3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rot="16200000">
            <a:off x="3428640" y="4138560"/>
            <a:ext cx="1434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A4_54N07.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rot="16200000">
            <a:off x="3193920" y="4138560"/>
            <a:ext cx="1434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A4_54N07.4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rot="16200000">
            <a:off x="2693880" y="4138560"/>
            <a:ext cx="1434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A4_54N07.4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2306520" y="4886280"/>
            <a:ext cx="1879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A4_54N07 (99Kb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5527800" y="5681520"/>
            <a:ext cx="1976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BP_91N22 (155Kb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rot="16200000">
            <a:off x="3092040" y="6457680"/>
            <a:ext cx="143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BP_91N22.6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rot="16200000">
            <a:off x="3585960" y="6457680"/>
            <a:ext cx="143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BP_91N22.7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rot="16200000">
            <a:off x="3935160" y="6457680"/>
            <a:ext cx="143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BP_91N22.7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rot="16200000">
            <a:off x="4049640" y="6457680"/>
            <a:ext cx="143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BP_91N22.7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rot="16200000">
            <a:off x="4163760" y="6457680"/>
            <a:ext cx="143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BP_91N22.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 rot="16200000">
            <a:off x="4255920" y="6457680"/>
            <a:ext cx="143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BP_91N22.8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rot="16200000">
            <a:off x="4385880" y="6457680"/>
            <a:ext cx="143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BP_91N22.8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rot="16200000">
            <a:off x="2896920" y="4138560"/>
            <a:ext cx="1434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A4_54N07.4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rot="16200000">
            <a:off x="3276360" y="6457680"/>
            <a:ext cx="143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BP_91N22.7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rot="16200000">
            <a:off x="3808080" y="6457680"/>
            <a:ext cx="143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BP_91N22.7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rot="16200000">
            <a:off x="4093920" y="4138560"/>
            <a:ext cx="1434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A4_54N07.28 </a:t>
            </a:r>
            <a:r>
              <a:rPr b="1" lang="en-GB" sz="800" spc="-1" strike="noStrike">
                <a:solidFill>
                  <a:srgbClr val="000000"/>
                </a:solidFill>
                <a:latin typeface="Arial"/>
              </a:rPr>
              <a:t>(CIR56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rot="16200000">
            <a:off x="2795400" y="4138560"/>
            <a:ext cx="1434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A4_54N07.4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 rot="16200000">
            <a:off x="4503600" y="6457680"/>
            <a:ext cx="143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(CIR560) MBP_91N22.8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5823000" y="4900680"/>
            <a:ext cx="96840" cy="176040"/>
          </a:xfrm>
          <a:custGeom>
            <a:avLst/>
            <a:gdLst>
              <a:gd name="textAreaLeft" fmla="*/ 0 w 96840"/>
              <a:gd name="textAreaRight" fmla="*/ 97200 w 9684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 rot="10800000">
            <a:off x="4344840" y="4902120"/>
            <a:ext cx="82800" cy="176400"/>
          </a:xfrm>
          <a:custGeom>
            <a:avLst/>
            <a:gdLst>
              <a:gd name="textAreaLeft" fmla="*/ 0 w 82800"/>
              <a:gd name="textAreaRight" fmla="*/ 83160 w 8280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rot="10800000">
            <a:off x="4462200" y="4902120"/>
            <a:ext cx="81000" cy="176400"/>
          </a:xfrm>
          <a:custGeom>
            <a:avLst/>
            <a:gdLst>
              <a:gd name="textAreaLeft" fmla="*/ 0 w 81000"/>
              <a:gd name="textAreaRight" fmla="*/ 81000 w 8100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 rot="10800000">
            <a:off x="4098600" y="4902120"/>
            <a:ext cx="82440" cy="176400"/>
          </a:xfrm>
          <a:custGeom>
            <a:avLst/>
            <a:gdLst>
              <a:gd name="textAreaLeft" fmla="*/ 0 w 82440"/>
              <a:gd name="textAreaRight" fmla="*/ 82800 w 8244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rot="10800000">
            <a:off x="4254120" y="4902120"/>
            <a:ext cx="34920" cy="176400"/>
          </a:xfrm>
          <a:custGeom>
            <a:avLst/>
            <a:gdLst>
              <a:gd name="textAreaLeft" fmla="*/ 0 w 34920"/>
              <a:gd name="textAreaRight" fmla="*/ 35280 w 3492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422520" y="4900680"/>
            <a:ext cx="22320" cy="176040"/>
          </a:xfrm>
          <a:custGeom>
            <a:avLst/>
            <a:gdLst>
              <a:gd name="textAreaLeft" fmla="*/ 0 w 22320"/>
              <a:gd name="textAreaRight" fmla="*/ 22680 w 2232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4559400" y="4900680"/>
            <a:ext cx="52200" cy="176040"/>
          </a:xfrm>
          <a:custGeom>
            <a:avLst/>
            <a:gdLst>
              <a:gd name="textAreaLeft" fmla="*/ 0 w 52200"/>
              <a:gd name="textAreaRight" fmla="*/ 52560 w 5220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3564000" y="4900680"/>
            <a:ext cx="25200" cy="176040"/>
          </a:xfrm>
          <a:custGeom>
            <a:avLst/>
            <a:gdLst>
              <a:gd name="textAreaLeft" fmla="*/ 0 w 25200"/>
              <a:gd name="textAreaRight" fmla="*/ 25560 w 2520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4695840" y="4900680"/>
            <a:ext cx="79200" cy="176040"/>
          </a:xfrm>
          <a:custGeom>
            <a:avLst/>
            <a:gdLst>
              <a:gd name="textAreaLeft" fmla="*/ 0 w 79200"/>
              <a:gd name="textAreaRight" fmla="*/ 79560 w 7920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4781520" y="4900680"/>
            <a:ext cx="39600" cy="176040"/>
          </a:xfrm>
          <a:custGeom>
            <a:avLst/>
            <a:gdLst>
              <a:gd name="textAreaLeft" fmla="*/ 0 w 39600"/>
              <a:gd name="textAreaRight" fmla="*/ 39960 w 3960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 rot="10800000">
            <a:off x="4860720" y="4902120"/>
            <a:ext cx="21960" cy="176400"/>
          </a:xfrm>
          <a:custGeom>
            <a:avLst/>
            <a:gdLst>
              <a:gd name="textAreaLeft" fmla="*/ 0 w 21960"/>
              <a:gd name="textAreaRight" fmla="*/ 22320 w 2196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5119560" y="4900680"/>
            <a:ext cx="87480" cy="176040"/>
          </a:xfrm>
          <a:custGeom>
            <a:avLst/>
            <a:gdLst>
              <a:gd name="textAreaLeft" fmla="*/ 0 w 87480"/>
              <a:gd name="textAreaRight" fmla="*/ 87480 w 8748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 rot="10800000">
            <a:off x="5202000" y="4902120"/>
            <a:ext cx="75960" cy="176400"/>
          </a:xfrm>
          <a:custGeom>
            <a:avLst/>
            <a:gdLst>
              <a:gd name="textAreaLeft" fmla="*/ 0 w 75960"/>
              <a:gd name="textAreaRight" fmla="*/ 76320 w 7596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 rot="10800000">
            <a:off x="5286240" y="4902120"/>
            <a:ext cx="22320" cy="176400"/>
          </a:xfrm>
          <a:custGeom>
            <a:avLst/>
            <a:gdLst>
              <a:gd name="textAreaLeft" fmla="*/ 0 w 22320"/>
              <a:gd name="textAreaRight" fmla="*/ 22680 w 2232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 rot="10800000">
            <a:off x="5319720" y="4902120"/>
            <a:ext cx="30240" cy="176400"/>
          </a:xfrm>
          <a:custGeom>
            <a:avLst/>
            <a:gdLst>
              <a:gd name="textAreaLeft" fmla="*/ 0 w 30240"/>
              <a:gd name="textAreaRight" fmla="*/ 30240 w 3024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rot="10800000">
            <a:off x="5418000" y="4902120"/>
            <a:ext cx="22320" cy="176400"/>
          </a:xfrm>
          <a:custGeom>
            <a:avLst/>
            <a:gdLst>
              <a:gd name="textAreaLeft" fmla="*/ 0 w 22320"/>
              <a:gd name="textAreaRight" fmla="*/ 22680 w 2232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5348160" y="4900680"/>
            <a:ext cx="44640" cy="176040"/>
          </a:xfrm>
          <a:custGeom>
            <a:avLst/>
            <a:gdLst>
              <a:gd name="textAreaLeft" fmla="*/ 0 w 44640"/>
              <a:gd name="textAreaRight" fmla="*/ 45000 w 4464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 rot="10800000">
            <a:off x="5746680" y="4902120"/>
            <a:ext cx="22320" cy="176400"/>
          </a:xfrm>
          <a:custGeom>
            <a:avLst/>
            <a:gdLst>
              <a:gd name="textAreaLeft" fmla="*/ 0 w 22320"/>
              <a:gd name="textAreaRight" fmla="*/ 22680 w 2232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5962680" y="4900680"/>
            <a:ext cx="65160" cy="176040"/>
          </a:xfrm>
          <a:custGeom>
            <a:avLst/>
            <a:gdLst>
              <a:gd name="textAreaLeft" fmla="*/ 0 w 65160"/>
              <a:gd name="textAreaRight" fmla="*/ 65160 w 6516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 rot="10800000">
            <a:off x="6575400" y="4902120"/>
            <a:ext cx="69840" cy="176400"/>
          </a:xfrm>
          <a:custGeom>
            <a:avLst/>
            <a:gdLst>
              <a:gd name="textAreaLeft" fmla="*/ 0 w 69840"/>
              <a:gd name="textAreaRight" fmla="*/ 69840 w 6984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 rot="10800000">
            <a:off x="6168960" y="4902120"/>
            <a:ext cx="303120" cy="176400"/>
          </a:xfrm>
          <a:custGeom>
            <a:avLst/>
            <a:gdLst>
              <a:gd name="textAreaLeft" fmla="*/ 0 w 303120"/>
              <a:gd name="textAreaRight" fmla="*/ 303480 w 30312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 rot="10800000">
            <a:off x="6093000" y="4902120"/>
            <a:ext cx="41040" cy="176400"/>
          </a:xfrm>
          <a:custGeom>
            <a:avLst/>
            <a:gdLst>
              <a:gd name="textAreaLeft" fmla="*/ 0 w 41040"/>
              <a:gd name="textAreaRight" fmla="*/ 41400 w 4104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146160" y="5800680"/>
            <a:ext cx="5330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338040" y="5711760"/>
            <a:ext cx="88920" cy="176400"/>
          </a:xfrm>
          <a:custGeom>
            <a:avLst/>
            <a:gdLst>
              <a:gd name="textAreaLeft" fmla="*/ 0 w 88920"/>
              <a:gd name="textAreaRight" fmla="*/ 89280 w 8892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 rot="10800000">
            <a:off x="128160" y="5713200"/>
            <a:ext cx="71640" cy="176040"/>
          </a:xfrm>
          <a:custGeom>
            <a:avLst/>
            <a:gdLst>
              <a:gd name="textAreaLeft" fmla="*/ 0 w 71640"/>
              <a:gd name="textAreaRight" fmla="*/ 72000 w 7164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 rot="10800000">
            <a:off x="434880" y="5713200"/>
            <a:ext cx="136800" cy="176040"/>
          </a:xfrm>
          <a:custGeom>
            <a:avLst/>
            <a:gdLst>
              <a:gd name="textAreaLeft" fmla="*/ 0 w 136800"/>
              <a:gd name="textAreaRight" fmla="*/ 137160 w 13680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 rot="10800000">
            <a:off x="606600" y="5713200"/>
            <a:ext cx="77760" cy="176040"/>
          </a:xfrm>
          <a:custGeom>
            <a:avLst/>
            <a:gdLst>
              <a:gd name="textAreaLeft" fmla="*/ 0 w 77760"/>
              <a:gd name="textAreaRight" fmla="*/ 78120 w 7776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714240" y="5711760"/>
            <a:ext cx="101880" cy="176400"/>
          </a:xfrm>
          <a:custGeom>
            <a:avLst/>
            <a:gdLst>
              <a:gd name="textAreaLeft" fmla="*/ 0 w 101880"/>
              <a:gd name="textAreaRight" fmla="*/ 102240 w 10188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839880" y="5711760"/>
            <a:ext cx="33120" cy="176400"/>
          </a:xfrm>
          <a:custGeom>
            <a:avLst/>
            <a:gdLst>
              <a:gd name="textAreaLeft" fmla="*/ 0 w 33120"/>
              <a:gd name="textAreaRight" fmla="*/ 33480 w 3312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900000" y="5711760"/>
            <a:ext cx="34920" cy="176400"/>
          </a:xfrm>
          <a:custGeom>
            <a:avLst/>
            <a:gdLst>
              <a:gd name="textAreaLeft" fmla="*/ 0 w 34920"/>
              <a:gd name="textAreaRight" fmla="*/ 35280 w 3492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 rot="10800000">
            <a:off x="968040" y="5713200"/>
            <a:ext cx="114120" cy="176040"/>
          </a:xfrm>
          <a:custGeom>
            <a:avLst/>
            <a:gdLst>
              <a:gd name="textAreaLeft" fmla="*/ 0 w 114120"/>
              <a:gd name="textAreaRight" fmla="*/ 114480 w 11412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 rot="10800000">
            <a:off x="1115640" y="5713200"/>
            <a:ext cx="144360" cy="176040"/>
          </a:xfrm>
          <a:custGeom>
            <a:avLst/>
            <a:gdLst>
              <a:gd name="textAreaLeft" fmla="*/ 0 w 144360"/>
              <a:gd name="textAreaRight" fmla="*/ 144360 w 14436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1268280" y="5711760"/>
            <a:ext cx="20880" cy="176400"/>
          </a:xfrm>
          <a:custGeom>
            <a:avLst/>
            <a:gdLst>
              <a:gd name="textAreaLeft" fmla="*/ 0 w 20880"/>
              <a:gd name="textAreaRight" fmla="*/ 21240 w 2088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1300320" y="5711760"/>
            <a:ext cx="125280" cy="176400"/>
          </a:xfrm>
          <a:custGeom>
            <a:avLst/>
            <a:gdLst>
              <a:gd name="textAreaLeft" fmla="*/ 0 w 125280"/>
              <a:gd name="textAreaRight" fmla="*/ 125640 w 12528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rot="10800000">
            <a:off x="1444320" y="5713200"/>
            <a:ext cx="68040" cy="176040"/>
          </a:xfrm>
          <a:custGeom>
            <a:avLst/>
            <a:gdLst>
              <a:gd name="textAreaLeft" fmla="*/ 0 w 68040"/>
              <a:gd name="textAreaRight" fmla="*/ 68400 w 6804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1522440" y="5711760"/>
            <a:ext cx="66600" cy="176400"/>
          </a:xfrm>
          <a:custGeom>
            <a:avLst/>
            <a:gdLst>
              <a:gd name="textAreaLeft" fmla="*/ 0 w 66600"/>
              <a:gd name="textAreaRight" fmla="*/ 66960 w 6660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1638360" y="5711760"/>
            <a:ext cx="166680" cy="176400"/>
          </a:xfrm>
          <a:custGeom>
            <a:avLst/>
            <a:gdLst>
              <a:gd name="textAreaLeft" fmla="*/ 0 w 166680"/>
              <a:gd name="textAreaRight" fmla="*/ 166680 w 16668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rot="10800000">
            <a:off x="1803240" y="5713200"/>
            <a:ext cx="69840" cy="176040"/>
          </a:xfrm>
          <a:custGeom>
            <a:avLst/>
            <a:gdLst>
              <a:gd name="textAreaLeft" fmla="*/ 0 w 69840"/>
              <a:gd name="textAreaRight" fmla="*/ 69840 w 6984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rot="10800000">
            <a:off x="1896840" y="5713200"/>
            <a:ext cx="158760" cy="176040"/>
          </a:xfrm>
          <a:custGeom>
            <a:avLst/>
            <a:gdLst>
              <a:gd name="textAreaLeft" fmla="*/ 0 w 158760"/>
              <a:gd name="textAreaRight" fmla="*/ 159120 w 15876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rot="10800000">
            <a:off x="2185560" y="5713200"/>
            <a:ext cx="34920" cy="176040"/>
          </a:xfrm>
          <a:custGeom>
            <a:avLst/>
            <a:gdLst>
              <a:gd name="textAreaLeft" fmla="*/ 0 w 34920"/>
              <a:gd name="textAreaRight" fmla="*/ 35280 w 3492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2063880" y="5711760"/>
            <a:ext cx="42840" cy="176400"/>
          </a:xfrm>
          <a:custGeom>
            <a:avLst/>
            <a:gdLst>
              <a:gd name="textAreaLeft" fmla="*/ 0 w 42840"/>
              <a:gd name="textAreaRight" fmla="*/ 43200 w 4284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2111400" y="5711760"/>
            <a:ext cx="50760" cy="176400"/>
          </a:xfrm>
          <a:custGeom>
            <a:avLst/>
            <a:gdLst>
              <a:gd name="textAreaLeft" fmla="*/ 0 w 50760"/>
              <a:gd name="textAreaRight" fmla="*/ 51120 w 5076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 rot="10800000">
            <a:off x="2296800" y="5713200"/>
            <a:ext cx="81000" cy="176040"/>
          </a:xfrm>
          <a:custGeom>
            <a:avLst/>
            <a:gdLst>
              <a:gd name="textAreaLeft" fmla="*/ 0 w 81000"/>
              <a:gd name="textAreaRight" fmla="*/ 81000 w 8100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2386080" y="5711760"/>
            <a:ext cx="52200" cy="176400"/>
          </a:xfrm>
          <a:custGeom>
            <a:avLst/>
            <a:gdLst>
              <a:gd name="textAreaLeft" fmla="*/ 0 w 52200"/>
              <a:gd name="textAreaRight" fmla="*/ 52560 w 5220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 rot="10800000">
            <a:off x="2469960" y="5713200"/>
            <a:ext cx="37800" cy="176040"/>
          </a:xfrm>
          <a:custGeom>
            <a:avLst/>
            <a:gdLst>
              <a:gd name="textAreaLeft" fmla="*/ 0 w 37800"/>
              <a:gd name="textAreaRight" fmla="*/ 38160 w 3780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2546280" y="5711760"/>
            <a:ext cx="69840" cy="176400"/>
          </a:xfrm>
          <a:custGeom>
            <a:avLst/>
            <a:gdLst>
              <a:gd name="textAreaLeft" fmla="*/ 0 w 69840"/>
              <a:gd name="textAreaRight" fmla="*/ 69840 w 6984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rot="10800000">
            <a:off x="2778120" y="5713200"/>
            <a:ext cx="22320" cy="176040"/>
          </a:xfrm>
          <a:custGeom>
            <a:avLst/>
            <a:gdLst>
              <a:gd name="textAreaLeft" fmla="*/ 0 w 22320"/>
              <a:gd name="textAreaRight" fmla="*/ 22680 w 2232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rot="10800000">
            <a:off x="2863800" y="5713200"/>
            <a:ext cx="22320" cy="176040"/>
          </a:xfrm>
          <a:custGeom>
            <a:avLst/>
            <a:gdLst>
              <a:gd name="textAreaLeft" fmla="*/ 0 w 22320"/>
              <a:gd name="textAreaRight" fmla="*/ 22680 w 2232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2889360" y="5711760"/>
            <a:ext cx="52200" cy="176400"/>
          </a:xfrm>
          <a:custGeom>
            <a:avLst/>
            <a:gdLst>
              <a:gd name="textAreaLeft" fmla="*/ 0 w 52200"/>
              <a:gd name="textAreaRight" fmla="*/ 52560 w 5220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 rot="10800000">
            <a:off x="2971800" y="5713200"/>
            <a:ext cx="101520" cy="176040"/>
          </a:xfrm>
          <a:custGeom>
            <a:avLst/>
            <a:gdLst>
              <a:gd name="textAreaLeft" fmla="*/ 0 w 101520"/>
              <a:gd name="textAreaRight" fmla="*/ 101880 w 10152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rot="10800000">
            <a:off x="3080880" y="5713200"/>
            <a:ext cx="25560" cy="176040"/>
          </a:xfrm>
          <a:custGeom>
            <a:avLst/>
            <a:gdLst>
              <a:gd name="textAreaLeft" fmla="*/ 0 w 25560"/>
              <a:gd name="textAreaRight" fmla="*/ 25920 w 2556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3112920" y="5711760"/>
            <a:ext cx="30240" cy="176400"/>
          </a:xfrm>
          <a:custGeom>
            <a:avLst/>
            <a:gdLst>
              <a:gd name="textAreaLeft" fmla="*/ 0 w 30240"/>
              <a:gd name="textAreaRight" fmla="*/ 30240 w 3024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rot="10800000">
            <a:off x="3211200" y="5713200"/>
            <a:ext cx="230040" cy="176040"/>
          </a:xfrm>
          <a:custGeom>
            <a:avLst/>
            <a:gdLst>
              <a:gd name="textAreaLeft" fmla="*/ 0 w 230040"/>
              <a:gd name="textAreaRight" fmla="*/ 230400 w 23004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3548160" y="5710320"/>
            <a:ext cx="31680" cy="176040"/>
          </a:xfrm>
          <a:custGeom>
            <a:avLst/>
            <a:gdLst>
              <a:gd name="textAreaLeft" fmla="*/ 0 w 31680"/>
              <a:gd name="textAreaRight" fmla="*/ 32040 w 3168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 rot="10800000">
            <a:off x="3604680" y="5713200"/>
            <a:ext cx="125640" cy="174600"/>
          </a:xfrm>
          <a:custGeom>
            <a:avLst/>
            <a:gdLst>
              <a:gd name="textAreaLeft" fmla="*/ 0 w 125640"/>
              <a:gd name="textAreaRight" fmla="*/ 126000 w 125640"/>
              <a:gd name="textAreaTop" fmla="*/ 0 h 174600"/>
              <a:gd name="textAreaBottom" fmla="*/ 174960 h 174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3805200" y="5710320"/>
            <a:ext cx="38160" cy="176040"/>
          </a:xfrm>
          <a:custGeom>
            <a:avLst/>
            <a:gdLst>
              <a:gd name="textAreaLeft" fmla="*/ 0 w 38160"/>
              <a:gd name="textAreaRight" fmla="*/ 38520 w 3816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 rot="10800000">
            <a:off x="3863520" y="5713200"/>
            <a:ext cx="65160" cy="174600"/>
          </a:xfrm>
          <a:custGeom>
            <a:avLst/>
            <a:gdLst>
              <a:gd name="textAreaLeft" fmla="*/ 0 w 65160"/>
              <a:gd name="textAreaRight" fmla="*/ 65160 w 65160"/>
              <a:gd name="textAreaTop" fmla="*/ 0 h 174600"/>
              <a:gd name="textAreaBottom" fmla="*/ 174960 h 174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3951360" y="5710320"/>
            <a:ext cx="84240" cy="176040"/>
          </a:xfrm>
          <a:custGeom>
            <a:avLst/>
            <a:gdLst>
              <a:gd name="textAreaLeft" fmla="*/ 0 w 84240"/>
              <a:gd name="textAreaRight" fmla="*/ 84600 w 8424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 rot="10800000">
            <a:off x="4111200" y="5713200"/>
            <a:ext cx="319320" cy="174600"/>
          </a:xfrm>
          <a:custGeom>
            <a:avLst/>
            <a:gdLst>
              <a:gd name="textAreaLeft" fmla="*/ 0 w 319320"/>
              <a:gd name="textAreaRight" fmla="*/ 319680 w 319320"/>
              <a:gd name="textAreaTop" fmla="*/ 0 h 174600"/>
              <a:gd name="textAreaBottom" fmla="*/ 174960 h 174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 rot="10800000">
            <a:off x="4457880" y="5713200"/>
            <a:ext cx="101520" cy="174600"/>
          </a:xfrm>
          <a:custGeom>
            <a:avLst/>
            <a:gdLst>
              <a:gd name="textAreaLeft" fmla="*/ 0 w 101520"/>
              <a:gd name="textAreaRight" fmla="*/ 101880 w 101520"/>
              <a:gd name="textAreaTop" fmla="*/ 0 h 174600"/>
              <a:gd name="textAreaBottom" fmla="*/ 174960 h 174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 rot="10800000">
            <a:off x="4638600" y="5713200"/>
            <a:ext cx="30240" cy="174600"/>
          </a:xfrm>
          <a:custGeom>
            <a:avLst/>
            <a:gdLst>
              <a:gd name="textAreaLeft" fmla="*/ 0 w 30240"/>
              <a:gd name="textAreaRight" fmla="*/ 30240 w 30240"/>
              <a:gd name="textAreaTop" fmla="*/ 0 h 174600"/>
              <a:gd name="textAreaBottom" fmla="*/ 174960 h 174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 rot="10800000">
            <a:off x="4714920" y="5713200"/>
            <a:ext cx="79200" cy="174600"/>
          </a:xfrm>
          <a:custGeom>
            <a:avLst/>
            <a:gdLst>
              <a:gd name="textAreaLeft" fmla="*/ 0 w 79200"/>
              <a:gd name="textAreaRight" fmla="*/ 79560 w 79200"/>
              <a:gd name="textAreaTop" fmla="*/ 0 h 174600"/>
              <a:gd name="textAreaBottom" fmla="*/ 174960 h 174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 rot="10800000">
            <a:off x="4830840" y="5713200"/>
            <a:ext cx="79200" cy="174600"/>
          </a:xfrm>
          <a:custGeom>
            <a:avLst/>
            <a:gdLst>
              <a:gd name="textAreaLeft" fmla="*/ 0 w 79200"/>
              <a:gd name="textAreaRight" fmla="*/ 79560 w 79200"/>
              <a:gd name="textAreaTop" fmla="*/ 0 h 174600"/>
              <a:gd name="textAreaBottom" fmla="*/ 174960 h 174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4929120" y="5710320"/>
            <a:ext cx="38160" cy="176040"/>
          </a:xfrm>
          <a:custGeom>
            <a:avLst/>
            <a:gdLst>
              <a:gd name="textAreaLeft" fmla="*/ 0 w 38160"/>
              <a:gd name="textAreaRight" fmla="*/ 38520 w 3816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5062680" y="5710320"/>
            <a:ext cx="74520" cy="176040"/>
          </a:xfrm>
          <a:custGeom>
            <a:avLst/>
            <a:gdLst>
              <a:gd name="textAreaLeft" fmla="*/ 0 w 74520"/>
              <a:gd name="textAreaRight" fmla="*/ 74880 w 7452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5200560" y="5710320"/>
            <a:ext cx="38160" cy="176040"/>
          </a:xfrm>
          <a:custGeom>
            <a:avLst/>
            <a:gdLst>
              <a:gd name="textAreaLeft" fmla="*/ 0 w 38160"/>
              <a:gd name="textAreaRight" fmla="*/ 38520 w 3816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5370480" y="5710320"/>
            <a:ext cx="38160" cy="176040"/>
          </a:xfrm>
          <a:custGeom>
            <a:avLst/>
            <a:gdLst>
              <a:gd name="textAreaLeft" fmla="*/ 0 w 38160"/>
              <a:gd name="textAreaRight" fmla="*/ 38520 w 38160"/>
              <a:gd name="textAreaTop" fmla="*/ 0 h 176040"/>
              <a:gd name="textAreaBottom" fmla="*/ 176400 h 176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 rot="10800000">
            <a:off x="3728520" y="4902120"/>
            <a:ext cx="319320" cy="176400"/>
          </a:xfrm>
          <a:custGeom>
            <a:avLst/>
            <a:gdLst>
              <a:gd name="textAreaLeft" fmla="*/ 0 w 319320"/>
              <a:gd name="textAreaRight" fmla="*/ 319680 w 319320"/>
              <a:gd name="textAreaTop" fmla="*/ 0 h 176400"/>
              <a:gd name="textAreaBottom" fmla="*/ 176760 h 176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 rot="3760200">
            <a:off x="3348360" y="5286240"/>
            <a:ext cx="50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L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 rot="3760200">
            <a:off x="3453120" y="5292360"/>
            <a:ext cx="50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L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 rot="3760200">
            <a:off x="3554640" y="5292360"/>
            <a:ext cx="50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L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 rot="3760200">
            <a:off x="3845160" y="5292360"/>
            <a:ext cx="50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L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 rot="3760200">
            <a:off x="4084920" y="5279760"/>
            <a:ext cx="50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L2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 rot="3760200">
            <a:off x="4203360" y="5286240"/>
            <a:ext cx="50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L2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 rot="3712800">
            <a:off x="4322520" y="5295960"/>
            <a:ext cx="50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L2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 rot="3760200">
            <a:off x="4434120" y="5292360"/>
            <a:ext cx="50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L2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 rot="3760200">
            <a:off x="4534200" y="5279760"/>
            <a:ext cx="50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L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 rot="3760200">
            <a:off x="4637160" y="5279760"/>
            <a:ext cx="50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L2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 rot="3760200">
            <a:off x="4749480" y="5292360"/>
            <a:ext cx="50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L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 rot="16200000">
            <a:off x="3187440" y="6457680"/>
            <a:ext cx="143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MBP_91N22.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108000" y="4173480"/>
            <a:ext cx="34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 rot="10800000">
            <a:off x="3465360" y="4901760"/>
            <a:ext cx="61920" cy="174600"/>
          </a:xfrm>
          <a:custGeom>
            <a:avLst/>
            <a:gdLst>
              <a:gd name="textAreaLeft" fmla="*/ 0 w 61920"/>
              <a:gd name="textAreaRight" fmla="*/ 62280 w 61920"/>
              <a:gd name="textAreaTop" fmla="*/ 0 h 174600"/>
              <a:gd name="textAreaBottom" fmla="*/ 174960 h 174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18T22:14:46Z</dcterms:created>
  <dc:creator>CNRS</dc:creator>
  <dc:description/>
  <dc:language>en-US</dc:language>
  <cp:lastModifiedBy>CNRS</cp:lastModifiedBy>
  <dcterms:modified xsi:type="dcterms:W3CDTF">2008-01-18T22:20:09Z</dcterms:modified>
  <cp:revision>1</cp:revision>
  <dc:subject/>
  <dc:title>Diapositive 1</dc:title>
</cp:coreProperties>
</file>